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11088850" r:id="rId2"/>
    <p:sldId id="11088859" r:id="rId3"/>
    <p:sldId id="11088849" r:id="rId4"/>
  </p:sldIdLst>
  <p:sldSz cx="9601200" cy="12801600" type="A3"/>
  <p:notesSz cx="6858000" cy="9144000"/>
  <p:custDataLst>
    <p:tags r:id="rId6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orient="horz" pos="539" userDrawn="1">
          <p15:clr>
            <a:srgbClr val="A4A3A4"/>
          </p15:clr>
        </p15:guide>
        <p15:guide id="7" pos="4203" userDrawn="1">
          <p15:clr>
            <a:srgbClr val="A4A3A4"/>
          </p15:clr>
        </p15:guide>
        <p15:guide id="8" pos="416" userDrawn="1">
          <p15:clr>
            <a:srgbClr val="A4A3A4"/>
          </p15:clr>
        </p15:guide>
        <p15:guide id="9" pos="1391" userDrawn="1">
          <p15:clr>
            <a:srgbClr val="A4A3A4"/>
          </p15:clr>
        </p15:guide>
        <p15:guide id="10" orient="horz" pos="6799" userDrawn="1">
          <p15:clr>
            <a:srgbClr val="A4A3A4"/>
          </p15:clr>
        </p15:guide>
        <p15:guide id="11" orient="horz" pos="289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B1BFF"/>
    <a:srgbClr val="FF0000"/>
    <a:srgbClr val="0000FF"/>
    <a:srgbClr val="32B446"/>
    <a:srgbClr val="0F488E"/>
    <a:srgbClr val="E64635"/>
    <a:srgbClr val="BD6345"/>
    <a:srgbClr val="ED1E23"/>
    <a:srgbClr val="5D7A2B"/>
    <a:srgbClr val="FFE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006" autoAdjust="0"/>
    <p:restoredTop sz="94842" autoAdjust="0"/>
  </p:normalViewPr>
  <p:slideViewPr>
    <p:cSldViewPr snapToGrid="0" showGuides="1">
      <p:cViewPr>
        <p:scale>
          <a:sx n="100" d="100"/>
          <a:sy n="100" d="100"/>
        </p:scale>
        <p:origin x="509" y="-1594"/>
      </p:cViewPr>
      <p:guideLst>
        <p:guide orient="horz" pos="539"/>
        <p:guide pos="4203"/>
        <p:guide pos="416"/>
        <p:guide pos="1391"/>
        <p:guide orient="horz" pos="6799"/>
        <p:guide orient="horz" pos="289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2BEEB6-D504-4AF2-BE3D-865A14EEE460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F013D5-E9F3-4A9B-A377-459B6CBB8C2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3AF013D5-E9F3-4A9B-A377-459B6CBB8C29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/>
              <a:ea typeface="等线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194754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F8CDDF-E317-43FF-BADF-C9062BCD013C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12AB48-F10E-4200-9F91-E80F12578591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78B4D-88E8-4BD4-AB68-267F22874E80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F4504-0091-4AF6-A267-775AAC63B731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8FBA7-3149-4D94-9D84-567ECF55CC6F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C16E31-AF22-436A-81AE-690D8D592C53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56E3AE-DB7B-46B6-B7CB-5632EE19E8ED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2804B0-02DA-4878-9CA1-1CAC49C82079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6BB1CC-ABA6-4FC8-AE68-8485770E590C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E86020-4275-44C3-943B-8A8F5CC684A7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5F9AE-A5D2-4567-89F7-88ED35B74950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52CDE-1CA3-481E-8226-4A2124572C91}" type="datetime1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A4919-69CB-4CB5-818A-87F0AB7C42D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1.tiff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tiff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74A0C973-1066-E6E4-E6FD-D81FB5F3F84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94" t="6089" r="70179" b="16268"/>
          <a:stretch/>
        </p:blipFill>
        <p:spPr>
          <a:xfrm>
            <a:off x="1920046" y="1509274"/>
            <a:ext cx="1938025" cy="2024871"/>
          </a:xfrm>
          <a:prstGeom prst="rect">
            <a:avLst/>
          </a:prstGeom>
        </p:spPr>
      </p:pic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6BA4919-69CB-4CB5-818A-87F0AB7C42DB}" type="slidenum">
              <a:rPr kumimoji="0" lang="zh-CN" altLang="en-US" sz="126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zh-CN" altLang="en-US" sz="126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等线" panose="02010600030101010101" pitchFamily="2" charset="-122"/>
              <a:cs typeface="+mn-cs"/>
            </a:endParaRPr>
          </a:p>
        </p:txBody>
      </p:sp>
      <p:sp>
        <p:nvSpPr>
          <p:cNvPr id="151" name="文本框 150"/>
          <p:cNvSpPr txBox="1"/>
          <p:nvPr/>
        </p:nvSpPr>
        <p:spPr>
          <a:xfrm>
            <a:off x="299146" y="441655"/>
            <a:ext cx="3662221" cy="5678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ppendix</a:t>
            </a:r>
            <a:endParaRPr kumimoji="0" lang="zh-CN" altLang="zh-CN" sz="18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8710D4E-2B28-1664-805D-8A9DA9EDAE9F}"/>
              </a:ext>
            </a:extLst>
          </p:cNvPr>
          <p:cNvSpPr txBox="1"/>
          <p:nvPr/>
        </p:nvSpPr>
        <p:spPr>
          <a:xfrm>
            <a:off x="563205" y="7228099"/>
            <a:ext cx="8377913" cy="12234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5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Characterization of the BG505 UFO trimer bait protein. </a:t>
            </a:r>
            <a:endParaRPr kumimoji="0" lang="zh-CN" altLang="zh-CN" sz="105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kumimoji="0" lang="en-US" altLang="zh-CN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ize-exclusion chromatography (SEC) analysis of the lectin-purified UFO proteins. The lectin-purified Env proteins were separated using gel filtration chromatography on a </a:t>
            </a:r>
            <a:r>
              <a:rPr kumimoji="0" lang="en-US" altLang="zh-CN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erdex</a:t>
            </a:r>
            <a:r>
              <a:rPr kumimoji="0" lang="en-US" altLang="zh-CN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200 10/300 column (top). Peak fractions were pooled and further analyzed by native PAGE (bottom). Lane 1 was loaded with the lectin-purified standard of the BG505 UFO-</a:t>
            </a:r>
            <a:r>
              <a:rPr kumimoji="0" lang="en-US" altLang="zh-CN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vi</a:t>
            </a:r>
            <a:r>
              <a:rPr kumimoji="0" lang="en-US" altLang="zh-CN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ag protein. Lanes 2 to 9 were loaded with the sequentially collected fractions of the protein from the SEC column. The red arrow indicates the trimeric protein. </a:t>
            </a:r>
            <a:r>
              <a:rPr kumimoji="0" lang="en-US" altLang="zh-CN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kumimoji="0" lang="en-US" altLang="zh-CN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haracterization of the differently labeled BG505 UFO proteins.</a:t>
            </a:r>
            <a:r>
              <a:rPr kumimoji="0" lang="zh-CN" alt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</a:t>
            </a:r>
            <a:r>
              <a:rPr kumimoji="0" lang="zh-CN" altLang="en-US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5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nlabeled as well as biotin-, biotin-streptomycin-, and biotin-streptomycin-fluorescent-labeled</a:t>
            </a:r>
            <a:r>
              <a:rPr kumimoji="0" lang="en-US" altLang="zh-CN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BG505 UFO proteins were analyzed by native PAGE. </a:t>
            </a:r>
            <a:endParaRPr kumimoji="0" lang="zh-CN" altLang="zh-CN" sz="105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D077447-C09F-052C-5FD8-A1F664037B8F}"/>
              </a:ext>
            </a:extLst>
          </p:cNvPr>
          <p:cNvSpPr txBox="1"/>
          <p:nvPr/>
        </p:nvSpPr>
        <p:spPr bwMode="auto">
          <a:xfrm>
            <a:off x="1033238" y="5361700"/>
            <a:ext cx="710451" cy="26161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720 </a:t>
            </a:r>
            <a:r>
              <a:rPr kumimoji="0" lang="en-US" altLang="zh-CN" sz="11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Da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08A92464-AD03-566D-B295-7825C0CFA66C}"/>
              </a:ext>
            </a:extLst>
          </p:cNvPr>
          <p:cNvSpPr txBox="1"/>
          <p:nvPr/>
        </p:nvSpPr>
        <p:spPr bwMode="auto">
          <a:xfrm>
            <a:off x="1033238" y="5747275"/>
            <a:ext cx="710451" cy="26161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marL="0" marR="0" lvl="0" indent="0" algn="l" defTabSz="4572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480 </a:t>
            </a:r>
            <a:r>
              <a:rPr kumimoji="0" lang="en-US" altLang="zh-CN" sz="11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kDa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DCF0AE53-426E-9C8D-7904-3004D976D81B}"/>
              </a:ext>
            </a:extLst>
          </p:cNvPr>
          <p:cNvCxnSpPr/>
          <p:nvPr/>
        </p:nvCxnSpPr>
        <p:spPr bwMode="auto">
          <a:xfrm>
            <a:off x="1671944" y="5512964"/>
            <a:ext cx="109255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1DB61D18-805F-3E84-9828-55447DBD5C36}"/>
              </a:ext>
            </a:extLst>
          </p:cNvPr>
          <p:cNvCxnSpPr/>
          <p:nvPr/>
        </p:nvCxnSpPr>
        <p:spPr bwMode="auto">
          <a:xfrm>
            <a:off x="1671944" y="5896685"/>
            <a:ext cx="109255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pic>
        <p:nvPicPr>
          <p:cNvPr id="10" name="图片 9">
            <a:extLst>
              <a:ext uri="{FF2B5EF4-FFF2-40B4-BE49-F238E27FC236}">
                <a16:creationId xmlns:a16="http://schemas.microsoft.com/office/drawing/2014/main" id="{DF66414B-4ACB-E151-5ABA-5246E5F4BD7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2000"/>
                    </a14:imgEffect>
                    <a14:imgEffect>
                      <a14:saturation sat="0"/>
                    </a14:imgEffect>
                    <a14:imgEffect>
                      <a14:brightnessContrast bright="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232" t="38521" r="35569" b="35121"/>
          <a:stretch>
            <a:fillRect/>
          </a:stretch>
        </p:blipFill>
        <p:spPr>
          <a:xfrm>
            <a:off x="1788502" y="5096807"/>
            <a:ext cx="1658641" cy="189801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7FA6E8DD-DF6A-6B8B-2E16-F20A842F570C}"/>
              </a:ext>
            </a:extLst>
          </p:cNvPr>
          <p:cNvSpPr txBox="1"/>
          <p:nvPr/>
        </p:nvSpPr>
        <p:spPr>
          <a:xfrm>
            <a:off x="4290634" y="1989082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20 </a:t>
            </a:r>
            <a:r>
              <a:rPr kumimoji="0" lang="en-US" altLang="zh-CN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kumimoji="0" lang="zh-CN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88C50DC-C26C-D9A1-CE29-537E7F6F35DA}"/>
              </a:ext>
            </a:extLst>
          </p:cNvPr>
          <p:cNvSpPr txBox="1"/>
          <p:nvPr/>
        </p:nvSpPr>
        <p:spPr>
          <a:xfrm>
            <a:off x="4290634" y="2316266"/>
            <a:ext cx="68800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80 </a:t>
            </a:r>
            <a:r>
              <a:rPr kumimoji="0" lang="en-US" altLang="zh-CN" sz="105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Da</a:t>
            </a:r>
            <a:endParaRPr kumimoji="0" lang="zh-CN" altLang="en-US" sz="10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E136A1F-FDB1-FD3C-5DDA-705EE11F1716}"/>
              </a:ext>
            </a:extLst>
          </p:cNvPr>
          <p:cNvSpPr txBox="1"/>
          <p:nvPr/>
        </p:nvSpPr>
        <p:spPr>
          <a:xfrm>
            <a:off x="797180" y="1180465"/>
            <a:ext cx="4495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67DC09F-306E-634B-6852-035666DAE8D3}"/>
              </a:ext>
            </a:extLst>
          </p:cNvPr>
          <p:cNvSpPr txBox="1"/>
          <p:nvPr/>
        </p:nvSpPr>
        <p:spPr>
          <a:xfrm>
            <a:off x="797180" y="4484083"/>
            <a:ext cx="4495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</a:t>
            </a:r>
            <a:endParaRPr kumimoji="0" lang="zh-CN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5187C9C6-61E2-D932-CA53-F81EB29857D9}"/>
              </a:ext>
            </a:extLst>
          </p:cNvPr>
          <p:cNvGrpSpPr/>
          <p:nvPr/>
        </p:nvGrpSpPr>
        <p:grpSpPr>
          <a:xfrm>
            <a:off x="1122415" y="1502153"/>
            <a:ext cx="797629" cy="2031998"/>
            <a:chOff x="3090029" y="3246402"/>
            <a:chExt cx="614313" cy="1618250"/>
          </a:xfrm>
        </p:grpSpPr>
        <p:pic>
          <p:nvPicPr>
            <p:cNvPr id="87" name="图片 86">
              <a:extLst>
                <a:ext uri="{FF2B5EF4-FFF2-40B4-BE49-F238E27FC236}">
                  <a16:creationId xmlns:a16="http://schemas.microsoft.com/office/drawing/2014/main" id="{539398EE-8814-E59E-481D-8F19D14D64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5" t="6701" r="94305" b="16268"/>
            <a:stretch/>
          </p:blipFill>
          <p:spPr>
            <a:xfrm>
              <a:off x="3485600" y="3264792"/>
              <a:ext cx="218742" cy="1599860"/>
            </a:xfrm>
            <a:prstGeom prst="rect">
              <a:avLst/>
            </a:prstGeom>
          </p:spPr>
        </p:pic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65BF3DB9-B073-EE1E-2D09-C13E0CB82584}"/>
                </a:ext>
              </a:extLst>
            </p:cNvPr>
            <p:cNvSpPr txBox="1"/>
            <p:nvPr/>
          </p:nvSpPr>
          <p:spPr>
            <a:xfrm rot="16200000">
              <a:off x="2471277" y="3865154"/>
              <a:ext cx="1438990" cy="2014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1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bsorbance</a:t>
              </a:r>
              <a:r>
                <a:rPr kumimoji="0" lang="zh-CN" altLang="en-US" sz="11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（</a:t>
              </a:r>
              <a:r>
                <a:rPr kumimoji="0" lang="en-US" altLang="zh-CN" sz="11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t 280nm</a:t>
              </a:r>
              <a:r>
                <a:rPr kumimoji="0" lang="zh-CN" altLang="en-US" sz="11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）</a:t>
              </a: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E0A1CB02-9B50-63D9-7247-7314AFB48727}"/>
                </a:ext>
              </a:extLst>
            </p:cNvPr>
            <p:cNvSpPr txBox="1"/>
            <p:nvPr/>
          </p:nvSpPr>
          <p:spPr>
            <a:xfrm>
              <a:off x="3348814" y="4612841"/>
              <a:ext cx="186670" cy="1715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B35F6C1B-F10E-F840-4496-1071D7800D17}"/>
                </a:ext>
              </a:extLst>
            </p:cNvPr>
            <p:cNvSpPr txBox="1"/>
            <p:nvPr/>
          </p:nvSpPr>
          <p:spPr>
            <a:xfrm>
              <a:off x="3219825" y="3988150"/>
              <a:ext cx="339759" cy="183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00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B27ACFAC-5DC7-BD8B-1F66-35CCDA37C248}"/>
                </a:ext>
              </a:extLst>
            </p:cNvPr>
            <p:cNvSpPr txBox="1"/>
            <p:nvPr/>
          </p:nvSpPr>
          <p:spPr>
            <a:xfrm>
              <a:off x="3218057" y="3364476"/>
              <a:ext cx="339759" cy="183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200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4DEA0C1D-510C-DA28-C085-FF65A2634C4F}"/>
              </a:ext>
            </a:extLst>
          </p:cNvPr>
          <p:cNvSpPr txBox="1"/>
          <p:nvPr/>
        </p:nvSpPr>
        <p:spPr>
          <a:xfrm rot="19608128">
            <a:off x="3045121" y="4329391"/>
            <a:ext cx="218223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io-SA-fluorescent-labeled 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2AE6E38E-B2AE-F3F0-E1CC-2C0993EA9FF5}"/>
              </a:ext>
            </a:extLst>
          </p:cNvPr>
          <p:cNvSpPr txBox="1"/>
          <p:nvPr/>
        </p:nvSpPr>
        <p:spPr>
          <a:xfrm rot="19608128">
            <a:off x="1973123" y="4578452"/>
            <a:ext cx="126037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nlabeled</a:t>
            </a: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9B3801D-BF1C-3889-23E4-D63EFA9413A9}"/>
              </a:ext>
            </a:extLst>
          </p:cNvPr>
          <p:cNvSpPr txBox="1"/>
          <p:nvPr/>
        </p:nvSpPr>
        <p:spPr>
          <a:xfrm rot="19608128">
            <a:off x="2392826" y="4581765"/>
            <a:ext cx="126037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io-labeled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FB58F36-CED2-C409-7C20-E72659729F0A}"/>
              </a:ext>
            </a:extLst>
          </p:cNvPr>
          <p:cNvSpPr txBox="1"/>
          <p:nvPr/>
        </p:nvSpPr>
        <p:spPr>
          <a:xfrm rot="19608128">
            <a:off x="2699930" y="4345008"/>
            <a:ext cx="213352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io-SA-labeled  </a:t>
            </a: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4C98C966-7538-AFE6-E4D2-AD91B788D906}"/>
              </a:ext>
            </a:extLst>
          </p:cNvPr>
          <p:cNvCxnSpPr/>
          <p:nvPr/>
        </p:nvCxnSpPr>
        <p:spPr bwMode="auto">
          <a:xfrm>
            <a:off x="3468718" y="5592571"/>
            <a:ext cx="109255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38" name="TextBox 18">
            <a:extLst>
              <a:ext uri="{FF2B5EF4-FFF2-40B4-BE49-F238E27FC236}">
                <a16:creationId xmlns:a16="http://schemas.microsoft.com/office/drawing/2014/main" id="{39B7A546-E635-DE68-BF6A-8F8FF6DB57BF}"/>
              </a:ext>
            </a:extLst>
          </p:cNvPr>
          <p:cNvSpPr txBox="1"/>
          <p:nvPr/>
        </p:nvSpPr>
        <p:spPr>
          <a:xfrm>
            <a:off x="3525549" y="5454071"/>
            <a:ext cx="75233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rimer</a:t>
            </a: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F923A13A-0C29-4EBB-C0BA-F15130147938}"/>
              </a:ext>
            </a:extLst>
          </p:cNvPr>
          <p:cNvCxnSpPr/>
          <p:nvPr/>
        </p:nvCxnSpPr>
        <p:spPr>
          <a:xfrm>
            <a:off x="4979010" y="2127517"/>
            <a:ext cx="12981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672AA20F-5AED-9C2D-F302-2A9D28D4D1B5}"/>
              </a:ext>
            </a:extLst>
          </p:cNvPr>
          <p:cNvCxnSpPr/>
          <p:nvPr/>
        </p:nvCxnSpPr>
        <p:spPr>
          <a:xfrm>
            <a:off x="4979010" y="2449513"/>
            <a:ext cx="12981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图片 26">
            <a:extLst>
              <a:ext uri="{FF2B5EF4-FFF2-40B4-BE49-F238E27FC236}">
                <a16:creationId xmlns:a16="http://schemas.microsoft.com/office/drawing/2014/main" id="{549679B5-C34E-2503-BFC6-577C64CEF95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37000"/>
                    </a14:imgEffect>
                    <a14:imgEffect>
                      <a14:saturation sat="0"/>
                    </a14:imgEffect>
                    <a14:imgEffect>
                      <a14:colorTemperature colorTemp="5900"/>
                    </a14:imgEffect>
                    <a14:imgEffect>
                      <a14:brightnessContrast bright="4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194" t="22936" r="29970" b="26445"/>
          <a:stretch/>
        </p:blipFill>
        <p:spPr>
          <a:xfrm rot="16200000">
            <a:off x="5419529" y="1111384"/>
            <a:ext cx="1933155" cy="277595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883311B0-1BA5-229D-47D6-E481147F6EB2}"/>
              </a:ext>
            </a:extLst>
          </p:cNvPr>
          <p:cNvSpPr txBox="1"/>
          <p:nvPr/>
        </p:nvSpPr>
        <p:spPr>
          <a:xfrm>
            <a:off x="5560525" y="1316261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2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5FAC8B2-C41B-CD9F-5F2A-98E0C6E69348}"/>
              </a:ext>
            </a:extLst>
          </p:cNvPr>
          <p:cNvSpPr txBox="1"/>
          <p:nvPr/>
        </p:nvSpPr>
        <p:spPr>
          <a:xfrm>
            <a:off x="5864030" y="1316261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3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6C20CE5-D081-7837-29B7-894033B4C69E}"/>
              </a:ext>
            </a:extLst>
          </p:cNvPr>
          <p:cNvSpPr txBox="1"/>
          <p:nvPr/>
        </p:nvSpPr>
        <p:spPr>
          <a:xfrm>
            <a:off x="6142596" y="1316261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4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384D804-5F82-E51F-7B39-CE7375791A4D}"/>
              </a:ext>
            </a:extLst>
          </p:cNvPr>
          <p:cNvSpPr txBox="1"/>
          <p:nvPr/>
        </p:nvSpPr>
        <p:spPr>
          <a:xfrm>
            <a:off x="6421162" y="1316261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5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EB601C2D-CFEF-0C9C-1A0F-17A12723715B}"/>
              </a:ext>
            </a:extLst>
          </p:cNvPr>
          <p:cNvSpPr txBox="1"/>
          <p:nvPr/>
        </p:nvSpPr>
        <p:spPr>
          <a:xfrm>
            <a:off x="6691415" y="1316261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6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058966E-CEBE-872C-BAA0-7179816D8A68}"/>
              </a:ext>
            </a:extLst>
          </p:cNvPr>
          <p:cNvSpPr txBox="1"/>
          <p:nvPr/>
        </p:nvSpPr>
        <p:spPr>
          <a:xfrm>
            <a:off x="6969981" y="1316261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7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EA28F25-1276-7253-7557-1E25389C98F6}"/>
              </a:ext>
            </a:extLst>
          </p:cNvPr>
          <p:cNvSpPr txBox="1"/>
          <p:nvPr/>
        </p:nvSpPr>
        <p:spPr>
          <a:xfrm>
            <a:off x="7256860" y="1316261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8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44B9D34-48C1-40FD-0498-4D1FC5698A9D}"/>
              </a:ext>
            </a:extLst>
          </p:cNvPr>
          <p:cNvSpPr txBox="1"/>
          <p:nvPr/>
        </p:nvSpPr>
        <p:spPr>
          <a:xfrm>
            <a:off x="7543740" y="1316261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9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9F92E075-C58A-76BE-5E2A-C78F75E8FDAE}"/>
              </a:ext>
            </a:extLst>
          </p:cNvPr>
          <p:cNvSpPr txBox="1"/>
          <p:nvPr/>
        </p:nvSpPr>
        <p:spPr>
          <a:xfrm>
            <a:off x="5265333" y="1316261"/>
            <a:ext cx="2632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1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B8D7C345-257F-04D1-9A0C-222C9018AF88}"/>
              </a:ext>
            </a:extLst>
          </p:cNvPr>
          <p:cNvCxnSpPr/>
          <p:nvPr/>
        </p:nvCxnSpPr>
        <p:spPr bwMode="auto">
          <a:xfrm>
            <a:off x="7805559" y="2127517"/>
            <a:ext cx="152245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44" name="TextBox 18">
            <a:extLst>
              <a:ext uri="{FF2B5EF4-FFF2-40B4-BE49-F238E27FC236}">
                <a16:creationId xmlns:a16="http://schemas.microsoft.com/office/drawing/2014/main" id="{B6F9BC5D-91B0-20AA-6FF0-00FB2B8FCE65}"/>
              </a:ext>
            </a:extLst>
          </p:cNvPr>
          <p:cNvSpPr txBox="1"/>
          <p:nvPr/>
        </p:nvSpPr>
        <p:spPr>
          <a:xfrm>
            <a:off x="7884752" y="1989017"/>
            <a:ext cx="104835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rimer</a:t>
            </a: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624E7D85-9942-4FE9-2B7F-2C0D1E9E3307}"/>
              </a:ext>
            </a:extLst>
          </p:cNvPr>
          <p:cNvCxnSpPr/>
          <p:nvPr/>
        </p:nvCxnSpPr>
        <p:spPr bwMode="auto">
          <a:xfrm>
            <a:off x="4883477" y="2147752"/>
            <a:ext cx="109255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8B250F6A-8F20-C79B-F93A-452C29007074}"/>
              </a:ext>
            </a:extLst>
          </p:cNvPr>
          <p:cNvCxnSpPr/>
          <p:nvPr/>
        </p:nvCxnSpPr>
        <p:spPr bwMode="auto">
          <a:xfrm>
            <a:off x="4883477" y="2457451"/>
            <a:ext cx="109255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FC4C864C-F7F1-33B8-C959-EEC4F33139D3}"/>
              </a:ext>
            </a:extLst>
          </p:cNvPr>
          <p:cNvCxnSpPr>
            <a:cxnSpLocks/>
          </p:cNvCxnSpPr>
          <p:nvPr/>
        </p:nvCxnSpPr>
        <p:spPr>
          <a:xfrm>
            <a:off x="1790707" y="7074650"/>
            <a:ext cx="166594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7A05D27C-C87F-1C65-C255-E4205A870592}"/>
              </a:ext>
            </a:extLst>
          </p:cNvPr>
          <p:cNvSpPr txBox="1"/>
          <p:nvPr/>
        </p:nvSpPr>
        <p:spPr>
          <a:xfrm>
            <a:off x="1908579" y="7090620"/>
            <a:ext cx="14302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G505 UFO protein</a:t>
            </a:r>
            <a:endParaRPr lang="zh-CN" altLang="en-US" sz="11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AA8227F-4F3B-E919-1265-412806017B7A}"/>
              </a:ext>
            </a:extLst>
          </p:cNvPr>
          <p:cNvSpPr txBox="1"/>
          <p:nvPr/>
        </p:nvSpPr>
        <p:spPr>
          <a:xfrm>
            <a:off x="2209232" y="3609900"/>
            <a:ext cx="9909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olume </a:t>
            </a:r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mL)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25A949F-7C41-7417-D057-6500F1E2FD77}"/>
              </a:ext>
            </a:extLst>
          </p:cNvPr>
          <p:cNvSpPr txBox="1"/>
          <p:nvPr/>
        </p:nvSpPr>
        <p:spPr>
          <a:xfrm>
            <a:off x="1896375" y="346405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08B2D4A-649F-13AA-F005-F8FDB21E5CAD}"/>
              </a:ext>
            </a:extLst>
          </p:cNvPr>
          <p:cNvSpPr txBox="1"/>
          <p:nvPr/>
        </p:nvSpPr>
        <p:spPr>
          <a:xfrm>
            <a:off x="2720770" y="346405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4B3CAF4-B64C-869E-8033-486472B0C947}"/>
              </a:ext>
            </a:extLst>
          </p:cNvPr>
          <p:cNvSpPr txBox="1"/>
          <p:nvPr/>
        </p:nvSpPr>
        <p:spPr>
          <a:xfrm>
            <a:off x="3121537" y="346405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47B511B-2E66-0450-4A23-7299A267A7EF}"/>
              </a:ext>
            </a:extLst>
          </p:cNvPr>
          <p:cNvSpPr txBox="1"/>
          <p:nvPr/>
        </p:nvSpPr>
        <p:spPr>
          <a:xfrm>
            <a:off x="2285397" y="346405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18">
            <a:extLst>
              <a:ext uri="{FF2B5EF4-FFF2-40B4-BE49-F238E27FC236}">
                <a16:creationId xmlns:a16="http://schemas.microsoft.com/office/drawing/2014/main" id="{7040A337-2C64-1D08-2B16-F1DFF87A9176}"/>
              </a:ext>
            </a:extLst>
          </p:cNvPr>
          <p:cNvSpPr txBox="1"/>
          <p:nvPr/>
        </p:nvSpPr>
        <p:spPr>
          <a:xfrm>
            <a:off x="2353482" y="1299978"/>
            <a:ext cx="80599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1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rimer</a:t>
            </a: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21C0B3AC-5448-3CD8-1E81-293646833096}"/>
              </a:ext>
            </a:extLst>
          </p:cNvPr>
          <p:cNvCxnSpPr/>
          <p:nvPr/>
        </p:nvCxnSpPr>
        <p:spPr>
          <a:xfrm>
            <a:off x="1655986" y="1488242"/>
            <a:ext cx="0" cy="200136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A611A303-931F-3119-B169-904C620C7EC6}"/>
              </a:ext>
            </a:extLst>
          </p:cNvPr>
          <p:cNvCxnSpPr>
            <a:cxnSpLocks/>
          </p:cNvCxnSpPr>
          <p:nvPr/>
        </p:nvCxnSpPr>
        <p:spPr>
          <a:xfrm flipH="1">
            <a:off x="1655986" y="3483538"/>
            <a:ext cx="220208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82A9419B-6E57-2339-7B56-337B3A53B40A}"/>
              </a:ext>
            </a:extLst>
          </p:cNvPr>
          <p:cNvCxnSpPr>
            <a:cxnSpLocks/>
          </p:cNvCxnSpPr>
          <p:nvPr/>
        </p:nvCxnSpPr>
        <p:spPr>
          <a:xfrm>
            <a:off x="1634410" y="1759948"/>
            <a:ext cx="447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93666EFD-C8A5-DDE4-4DCD-963C778ED5AA}"/>
              </a:ext>
            </a:extLst>
          </p:cNvPr>
          <p:cNvCxnSpPr>
            <a:cxnSpLocks/>
          </p:cNvCxnSpPr>
          <p:nvPr/>
        </p:nvCxnSpPr>
        <p:spPr>
          <a:xfrm>
            <a:off x="1634410" y="2155918"/>
            <a:ext cx="447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9E6514BC-0C7F-2265-843F-BBDA5FA36A64}"/>
              </a:ext>
            </a:extLst>
          </p:cNvPr>
          <p:cNvCxnSpPr>
            <a:cxnSpLocks/>
          </p:cNvCxnSpPr>
          <p:nvPr/>
        </p:nvCxnSpPr>
        <p:spPr>
          <a:xfrm>
            <a:off x="1634410" y="2546440"/>
            <a:ext cx="447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69D576E1-057D-DE0D-A2A8-3A0BF82A5F44}"/>
              </a:ext>
            </a:extLst>
          </p:cNvPr>
          <p:cNvCxnSpPr>
            <a:cxnSpLocks/>
          </p:cNvCxnSpPr>
          <p:nvPr/>
        </p:nvCxnSpPr>
        <p:spPr>
          <a:xfrm>
            <a:off x="1634410" y="2938327"/>
            <a:ext cx="447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7DA7C7A2-5985-2FFB-FA32-CA8384759FF3}"/>
              </a:ext>
            </a:extLst>
          </p:cNvPr>
          <p:cNvCxnSpPr>
            <a:cxnSpLocks/>
          </p:cNvCxnSpPr>
          <p:nvPr/>
        </p:nvCxnSpPr>
        <p:spPr>
          <a:xfrm>
            <a:off x="1634410" y="3330212"/>
            <a:ext cx="447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FE85005A-0EC5-1E0F-32B6-60B24FA6FC5C}"/>
              </a:ext>
            </a:extLst>
          </p:cNvPr>
          <p:cNvCxnSpPr>
            <a:cxnSpLocks/>
          </p:cNvCxnSpPr>
          <p:nvPr/>
        </p:nvCxnSpPr>
        <p:spPr>
          <a:xfrm>
            <a:off x="1768872" y="3460504"/>
            <a:ext cx="0" cy="378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3A826506-DFB4-1E41-09DB-0DD5382D9359}"/>
              </a:ext>
            </a:extLst>
          </p:cNvPr>
          <p:cNvCxnSpPr>
            <a:cxnSpLocks/>
          </p:cNvCxnSpPr>
          <p:nvPr/>
        </p:nvCxnSpPr>
        <p:spPr>
          <a:xfrm>
            <a:off x="2053261" y="3460504"/>
            <a:ext cx="0" cy="378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D7D7266B-50A0-1275-B7E6-8893B56D88DE}"/>
              </a:ext>
            </a:extLst>
          </p:cNvPr>
          <p:cNvCxnSpPr>
            <a:cxnSpLocks/>
          </p:cNvCxnSpPr>
          <p:nvPr/>
        </p:nvCxnSpPr>
        <p:spPr>
          <a:xfrm>
            <a:off x="2465558" y="3460504"/>
            <a:ext cx="0" cy="378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D114ED8F-63E1-5F5D-C12B-6DDB0C3D7A9B}"/>
              </a:ext>
            </a:extLst>
          </p:cNvPr>
          <p:cNvCxnSpPr>
            <a:cxnSpLocks/>
          </p:cNvCxnSpPr>
          <p:nvPr/>
        </p:nvCxnSpPr>
        <p:spPr>
          <a:xfrm>
            <a:off x="2875132" y="3460504"/>
            <a:ext cx="0" cy="378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9D80C7A3-2EBA-EA75-5609-37B9D6609100}"/>
              </a:ext>
            </a:extLst>
          </p:cNvPr>
          <p:cNvCxnSpPr>
            <a:cxnSpLocks/>
          </p:cNvCxnSpPr>
          <p:nvPr/>
        </p:nvCxnSpPr>
        <p:spPr>
          <a:xfrm>
            <a:off x="3287429" y="3460504"/>
            <a:ext cx="0" cy="378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FE87A21A-0EE6-C2C4-407F-454E7E6E12FB}"/>
              </a:ext>
            </a:extLst>
          </p:cNvPr>
          <p:cNvCxnSpPr>
            <a:cxnSpLocks/>
          </p:cNvCxnSpPr>
          <p:nvPr/>
        </p:nvCxnSpPr>
        <p:spPr>
          <a:xfrm>
            <a:off x="3699150" y="3460504"/>
            <a:ext cx="0" cy="3782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8373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6BA4919-69CB-4CB5-818A-87F0AB7C42DB}" type="slidenum">
              <a:rPr kumimoji="0" lang="zh-CN" altLang="en-US" sz="126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zh-CN" altLang="en-US" sz="126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等线" panose="02010600030101010101" pitchFamily="2" charset="-122"/>
              <a:cs typeface="+mn-cs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6906E84D-05C3-9CE5-D908-15BA5449ADD1}"/>
              </a:ext>
            </a:extLst>
          </p:cNvPr>
          <p:cNvGrpSpPr/>
          <p:nvPr/>
        </p:nvGrpSpPr>
        <p:grpSpPr>
          <a:xfrm>
            <a:off x="5942177" y="3553716"/>
            <a:ext cx="3064256" cy="220886"/>
            <a:chOff x="5916228" y="7839866"/>
            <a:chExt cx="3064256" cy="220886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28D2D8BE-7D72-88C5-D827-2F99F6E83B13}"/>
                </a:ext>
              </a:extLst>
            </p:cNvPr>
            <p:cNvGrpSpPr/>
            <p:nvPr/>
          </p:nvGrpSpPr>
          <p:grpSpPr>
            <a:xfrm>
              <a:off x="5916228" y="7845308"/>
              <a:ext cx="782355" cy="215444"/>
              <a:chOff x="6129952" y="9564110"/>
              <a:chExt cx="782355" cy="215444"/>
            </a:xfrm>
          </p:grpSpPr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ACEC797A-AD2A-5682-1289-B4DD0170394F}"/>
                  </a:ext>
                </a:extLst>
              </p:cNvPr>
              <p:cNvSpPr/>
              <p:nvPr/>
            </p:nvSpPr>
            <p:spPr>
              <a:xfrm>
                <a:off x="6129952" y="9629265"/>
                <a:ext cx="106606" cy="84182"/>
              </a:xfrm>
              <a:prstGeom prst="rect">
                <a:avLst/>
              </a:prstGeom>
              <a:solidFill>
                <a:srgbClr val="FFE699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pitchFamily="2" charset="-122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27CB7006-B2DD-0886-EFA7-541405744728}"/>
                  </a:ext>
                </a:extLst>
              </p:cNvPr>
              <p:cNvSpPr txBox="1"/>
              <p:nvPr/>
            </p:nvSpPr>
            <p:spPr>
              <a:xfrm>
                <a:off x="6182620" y="9564110"/>
                <a:ext cx="7296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50-10 ug/ml</a:t>
                </a: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2F70D78C-18EA-048E-157D-DA62679971CB}"/>
                </a:ext>
              </a:extLst>
            </p:cNvPr>
            <p:cNvGrpSpPr/>
            <p:nvPr/>
          </p:nvGrpSpPr>
          <p:grpSpPr>
            <a:xfrm>
              <a:off x="6692720" y="7845308"/>
              <a:ext cx="747284" cy="215444"/>
              <a:chOff x="6908314" y="9564110"/>
              <a:chExt cx="747284" cy="215444"/>
            </a:xfrm>
          </p:grpSpPr>
          <p:sp>
            <p:nvSpPr>
              <p:cNvPr id="23" name="矩形 22">
                <a:extLst>
                  <a:ext uri="{FF2B5EF4-FFF2-40B4-BE49-F238E27FC236}">
                    <a16:creationId xmlns:a16="http://schemas.microsoft.com/office/drawing/2014/main" id="{95491712-88B6-6BAC-B01C-DDC7E6C964D1}"/>
                  </a:ext>
                </a:extLst>
              </p:cNvPr>
              <p:cNvSpPr/>
              <p:nvPr/>
            </p:nvSpPr>
            <p:spPr>
              <a:xfrm>
                <a:off x="6908314" y="9629265"/>
                <a:ext cx="106606" cy="84182"/>
              </a:xfrm>
              <a:prstGeom prst="rect">
                <a:avLst/>
              </a:prstGeom>
              <a:solidFill>
                <a:srgbClr val="FFC000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pitchFamily="2" charset="-122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B89B808C-F079-B295-BA58-26E0E1B86974}"/>
                  </a:ext>
                </a:extLst>
              </p:cNvPr>
              <p:cNvSpPr txBox="1"/>
              <p:nvPr/>
            </p:nvSpPr>
            <p:spPr>
              <a:xfrm>
                <a:off x="6954765" y="9564110"/>
                <a:ext cx="70083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0-2 ug/ml</a:t>
                </a: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940418EF-E0F3-D9C2-DD5C-70B3CEE930E1}"/>
                </a:ext>
              </a:extLst>
            </p:cNvPr>
            <p:cNvGrpSpPr/>
            <p:nvPr/>
          </p:nvGrpSpPr>
          <p:grpSpPr>
            <a:xfrm>
              <a:off x="7462995" y="7839866"/>
              <a:ext cx="750817" cy="215444"/>
              <a:chOff x="8027762" y="9558668"/>
              <a:chExt cx="750817" cy="215444"/>
            </a:xfrm>
          </p:grpSpPr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7BB05AE3-A9EB-1983-C4A2-B12E5E0F09E5}"/>
                  </a:ext>
                </a:extLst>
              </p:cNvPr>
              <p:cNvSpPr/>
              <p:nvPr/>
            </p:nvSpPr>
            <p:spPr>
              <a:xfrm>
                <a:off x="8027762" y="9629265"/>
                <a:ext cx="106606" cy="84182"/>
              </a:xfrm>
              <a:prstGeom prst="rect">
                <a:avLst/>
              </a:prstGeom>
              <a:solidFill>
                <a:srgbClr val="ED7D31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pitchFamily="2" charset="-122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7505357C-92F3-9B06-4FB7-47177A2D3873}"/>
                  </a:ext>
                </a:extLst>
              </p:cNvPr>
              <p:cNvSpPr txBox="1"/>
              <p:nvPr/>
            </p:nvSpPr>
            <p:spPr>
              <a:xfrm>
                <a:off x="8077746" y="9558668"/>
                <a:ext cx="70083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-0.2 ug/ml</a:t>
                </a: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2A495AF7-01BF-28AE-291B-1B64DC2EE4F4}"/>
                </a:ext>
              </a:extLst>
            </p:cNvPr>
            <p:cNvGrpSpPr/>
            <p:nvPr/>
          </p:nvGrpSpPr>
          <p:grpSpPr>
            <a:xfrm>
              <a:off x="8236804" y="7839866"/>
              <a:ext cx="743680" cy="215444"/>
              <a:chOff x="8748065" y="9558668"/>
              <a:chExt cx="743680" cy="215444"/>
            </a:xfrm>
          </p:grpSpPr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1763A61B-44A7-4682-00EB-EC21A71F78C3}"/>
                  </a:ext>
                </a:extLst>
              </p:cNvPr>
              <p:cNvSpPr/>
              <p:nvPr/>
            </p:nvSpPr>
            <p:spPr>
              <a:xfrm>
                <a:off x="8748065" y="9629265"/>
                <a:ext cx="106606" cy="84182"/>
              </a:xfrm>
              <a:prstGeom prst="rect">
                <a:avLst/>
              </a:prstGeom>
              <a:solidFill>
                <a:srgbClr val="FF0000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pitchFamily="2" charset="-122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1047409A-52C5-F0F7-94F9-9060A3005D5A}"/>
                  </a:ext>
                </a:extLst>
              </p:cNvPr>
              <p:cNvSpPr txBox="1"/>
              <p:nvPr/>
            </p:nvSpPr>
            <p:spPr>
              <a:xfrm>
                <a:off x="8790912" y="9558668"/>
                <a:ext cx="70083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&lt;0.2 ug/ml</a:t>
                </a:r>
                <a:endParaRPr kumimoji="0" lang="zh-CN" altLang="en-US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</p:grpSp>
      <p:graphicFrame>
        <p:nvGraphicFramePr>
          <p:cNvPr id="27" name="表格 26">
            <a:extLst>
              <a:ext uri="{FF2B5EF4-FFF2-40B4-BE49-F238E27FC236}">
                <a16:creationId xmlns:a16="http://schemas.microsoft.com/office/drawing/2014/main" id="{76AFDDF7-F578-1B7F-114E-F33ECA25B11B}"/>
              </a:ext>
            </a:extLst>
          </p:cNvPr>
          <p:cNvGraphicFramePr>
            <a:graphicFrameLocks noGrp="1"/>
          </p:cNvGraphicFramePr>
          <p:nvPr/>
        </p:nvGraphicFramePr>
        <p:xfrm>
          <a:off x="957729" y="909401"/>
          <a:ext cx="7983389" cy="2576713"/>
        </p:xfrm>
        <a:graphic>
          <a:graphicData uri="http://schemas.openxmlformats.org/drawingml/2006/table">
            <a:tbl>
              <a:tblPr/>
              <a:tblGrid>
                <a:gridCol w="59857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17"/>
                    </a:ext>
                  </a:extLst>
                </a:gridCol>
                <a:gridCol w="63174">
                  <a:extLst>
                    <a:ext uri="{9D8B030D-6E8A-4147-A177-3AD203B41FA5}">
                      <a16:colId xmlns:a16="http://schemas.microsoft.com/office/drawing/2014/main" val="20018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19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20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21"/>
                    </a:ext>
                  </a:extLst>
                </a:gridCol>
                <a:gridCol w="63174">
                  <a:extLst>
                    <a:ext uri="{9D8B030D-6E8A-4147-A177-3AD203B41FA5}">
                      <a16:colId xmlns:a16="http://schemas.microsoft.com/office/drawing/2014/main" val="20022"/>
                    </a:ext>
                  </a:extLst>
                </a:gridCol>
                <a:gridCol w="327079">
                  <a:extLst>
                    <a:ext uri="{9D8B030D-6E8A-4147-A177-3AD203B41FA5}">
                      <a16:colId xmlns:a16="http://schemas.microsoft.com/office/drawing/2014/main" val="20023"/>
                    </a:ext>
                  </a:extLst>
                </a:gridCol>
                <a:gridCol w="62053">
                  <a:extLst>
                    <a:ext uri="{9D8B030D-6E8A-4147-A177-3AD203B41FA5}">
                      <a16:colId xmlns:a16="http://schemas.microsoft.com/office/drawing/2014/main" val="20024"/>
                    </a:ext>
                  </a:extLst>
                </a:gridCol>
                <a:gridCol w="327756">
                  <a:extLst>
                    <a:ext uri="{9D8B030D-6E8A-4147-A177-3AD203B41FA5}">
                      <a16:colId xmlns:a16="http://schemas.microsoft.com/office/drawing/2014/main" val="20025"/>
                    </a:ext>
                  </a:extLst>
                </a:gridCol>
              </a:tblGrid>
              <a:tr h="315717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17"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ier 2</a:t>
                      </a:r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ier 1</a:t>
                      </a:r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微软雅黑" panose="020B0503020204020204" pitchFamily="34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vert="vert27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uto</a:t>
                      </a:r>
                      <a:r>
                        <a:rPr lang="zh-CN" alt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endParaRPr lang="zh-CN" alt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highlight>
                          <a:srgbClr val="FFFF00"/>
                        </a:highlight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36792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l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X1632（G）</a:t>
                      </a:r>
                    </a:p>
                  </a:txBody>
                  <a:tcPr marL="0" marR="0" marT="540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119（CRF07）</a:t>
                      </a:r>
                    </a:p>
                  </a:txBody>
                  <a:tcPr marL="0" marR="0" marT="216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RO11（B）</a:t>
                      </a:r>
                    </a:p>
                  </a:txBody>
                  <a:tcPr marL="0" marR="0" marT="504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46F3（AC）</a:t>
                      </a:r>
                    </a:p>
                  </a:txBody>
                  <a:tcPr marL="0" marR="0" marT="468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98F1（A）</a:t>
                      </a:r>
                    </a:p>
                  </a:txBody>
                  <a:tcPr marL="0" marR="0" marT="576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NE8（CRF01）</a:t>
                      </a:r>
                    </a:p>
                  </a:txBody>
                  <a:tcPr marL="0" marR="0" marT="288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NE55（CRF01）</a:t>
                      </a:r>
                    </a:p>
                  </a:txBody>
                  <a:tcPr marL="0" marR="0" marT="216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E0217（C）</a:t>
                      </a:r>
                    </a:p>
                  </a:txBody>
                  <a:tcPr marL="0" marR="0" marT="468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JOX2000（CRF01）</a:t>
                      </a:r>
                    </a:p>
                  </a:txBody>
                  <a:tcPr marL="0" marR="0" marT="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E1176（C）</a:t>
                      </a:r>
                    </a:p>
                  </a:txBody>
                  <a:tcPr marL="0" marR="0" marT="468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X2278（B）</a:t>
                      </a:r>
                    </a:p>
                  </a:txBody>
                  <a:tcPr marL="0" marR="0" marT="576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710（C）</a:t>
                      </a:r>
                    </a:p>
                  </a:txBody>
                  <a:tcPr marL="0" marR="0" marT="576000" marB="0" vert="vert27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ZM197M.PB7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0" marR="0" marT="144000" marB="0" vert="vert27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936-2.21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0" marR="0" marT="288000" marB="0" vert="vert27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C422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61.8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0" marR="0" marT="216000" marB="0" vert="vert27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WITO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160.33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0" marR="0" marT="144000" marB="0" vert="vert27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P4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200.G3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0" marR="0" marT="72000" marB="0" vert="vert27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vert="vert27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W965.26 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0" marR="0" marT="288000" marB="0" vert="vert27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F162.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L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（B）</a:t>
                      </a:r>
                    </a:p>
                  </a:txBody>
                  <a:tcPr marL="0" marR="0" marT="360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2RW020.2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0" marR="0" marT="252000" marB="0" vert="vert27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0" marR="0" marT="0" marB="0" vert="vert27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57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ipd3N4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（</a:t>
                      </a:r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</a:t>
                      </a:r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）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0" marR="0" marT="216000" marB="0" vert="vert27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LV</a:t>
                      </a:r>
                    </a:p>
                  </a:txBody>
                  <a:tcPr marL="0" marR="0" marT="1008000" marB="0" vert="vert27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3269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JT1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1.7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.4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.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4.6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17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6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91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85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endParaRPr lang="zh-CN" altLang="en-US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12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endParaRPr lang="en-US" altLang="zh-CN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3269"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J031</a:t>
                      </a:r>
                      <a:endParaRPr lang="en-US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7.1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7.6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8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.42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6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.71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.67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99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endParaRPr lang="zh-CN" altLang="en-US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6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endParaRPr lang="zh-CN" altLang="en-US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16</a:t>
                      </a:r>
                      <a:endParaRPr lang="en-US" altLang="zh-CN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endParaRPr lang="en-US" altLang="zh-CN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  <a:endParaRPr lang="en-US" altLang="zh-CN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3269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J</a:t>
                      </a:r>
                      <a:r>
                        <a:rPr 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1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8.3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8.7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2.9</a:t>
                      </a:r>
                      <a:endParaRPr lang="zh-CN" altLang="en-US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11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8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2.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57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0.5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6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44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.7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6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endParaRPr lang="en-US" altLang="zh-CN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3269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J029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3.5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9.4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.44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25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81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.73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28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14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endParaRPr lang="zh-CN" altLang="en-US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1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  <a:r>
                        <a:rPr lang="zh-CN" altLang="en-US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　　</a:t>
                      </a: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endParaRPr lang="zh-CN" altLang="en-US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8</a:t>
                      </a:r>
                      <a:endParaRPr lang="en-US" altLang="zh-CN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endParaRPr lang="en-US" altLang="zh-CN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60120" rtl="0" eaLnBrk="1" fontAlgn="b" latinLnBrk="0" hangingPunct="1"/>
                      <a:r>
                        <a:rPr lang="en-US" altLang="zh-CN" sz="9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  <a:endParaRPr lang="en-US" altLang="zh-CN" sz="900" b="0" i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276" marR="4276" marT="4276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0356B072-7DB9-5535-834E-6C91F9C4B9FB}"/>
              </a:ext>
            </a:extLst>
          </p:cNvPr>
          <p:cNvSpPr txBox="1"/>
          <p:nvPr/>
        </p:nvSpPr>
        <p:spPr>
          <a:xfrm>
            <a:off x="660400" y="3842605"/>
            <a:ext cx="8548914" cy="5770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50" b="1" i="0" u="none" strike="noStrike" kern="1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</a:t>
            </a:r>
            <a:r>
              <a:rPr kumimoji="0" lang="en-US" altLang="zh-CN" sz="105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Comparison of neutralization </a:t>
            </a:r>
            <a:r>
              <a:rPr kumimoji="0" lang="en-US" altLang="zh-CN" sz="1050" b="1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i</a:t>
            </a:r>
            <a:r>
              <a:rPr lang="en-US" altLang="zh-CN" sz="1050" b="1" kern="100" dirty="0" err="1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ers</a:t>
            </a:r>
            <a:r>
              <a:rPr kumimoji="0" lang="en-US" altLang="zh-CN" sz="105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mong different </a:t>
            </a:r>
            <a:r>
              <a:rPr kumimoji="0" lang="en-US" altLang="zh-CN" sz="1050" b="1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bs</a:t>
            </a:r>
            <a:r>
              <a:rPr kumimoji="0" lang="en-US" altLang="zh-CN" sz="105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kumimoji="0" lang="zh-CN" altLang="zh-CN" sz="105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5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ur </a:t>
            </a:r>
            <a:r>
              <a:rPr kumimoji="0" lang="en-US" altLang="zh-CN" sz="1050" b="0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bs</a:t>
            </a:r>
            <a:r>
              <a:rPr kumimoji="0" lang="en-US" altLang="zh-CN" sz="105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ere assayed against 17 tier 2 viruses, 3 tier 1 viruses, the autologous SHIV</a:t>
            </a:r>
            <a:r>
              <a:rPr kumimoji="0" lang="en-US" altLang="zh-CN" sz="1050" b="0" i="0" u="none" strike="noStrike" kern="1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157ipd3N4 </a:t>
            </a:r>
            <a:r>
              <a:rPr kumimoji="0" lang="en-US" altLang="zh-CN" sz="105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irus, and murine leukemia virus (MLV). The different colors represent the different neutralization potencies. </a:t>
            </a:r>
            <a:endParaRPr kumimoji="0" lang="zh-CN" altLang="zh-CN" sz="105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D6F4236-5331-92A1-22DF-6EDB35721C3F}"/>
              </a:ext>
            </a:extLst>
          </p:cNvPr>
          <p:cNvSpPr txBox="1"/>
          <p:nvPr/>
        </p:nvSpPr>
        <p:spPr>
          <a:xfrm>
            <a:off x="299146" y="203354"/>
            <a:ext cx="3662221" cy="5678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ppendix</a:t>
            </a:r>
            <a:endParaRPr kumimoji="0" lang="zh-CN" altLang="zh-CN" sz="18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6821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0" name="表格 119"/>
          <p:cNvGraphicFramePr>
            <a:graphicFrameLocks noGrp="1"/>
          </p:cNvGraphicFramePr>
          <p:nvPr/>
        </p:nvGraphicFramePr>
        <p:xfrm>
          <a:off x="2036618" y="953773"/>
          <a:ext cx="4818169" cy="5385852"/>
        </p:xfrm>
        <a:graphic>
          <a:graphicData uri="http://schemas.openxmlformats.org/drawingml/2006/table">
            <a:tbl>
              <a:tblPr/>
              <a:tblGrid>
                <a:gridCol w="125987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8957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8957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8957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8957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3811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endParaRPr lang="zh-CN" alt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lasma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ntibod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811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0" algn="ctr" defTabSz="914400" rtl="0" eaLnBrk="1" fontAlgn="ctr" latinLnBrk="0" hangingPunct="1"/>
                      <a:r>
                        <a:rPr lang="en-US" altLang="zh-CN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Virus</a:t>
                      </a:r>
                      <a:endParaRPr lang="zh-CN" altLang="en-US" sz="11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1015R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J038+JT1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J03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JT1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1632(G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1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1.6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.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119(CRF07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4.8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9.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.0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O.11(B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lt;3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9.2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.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6.4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F3(AC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lt;3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1.8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.4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.7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8F1(A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.0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9.4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1.4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NE8(CRF01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lt;3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NE55(CRF01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9.4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0.8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0217(C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.4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5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8.2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JOX200(CRF07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3.8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6.3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4.5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1176(C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lt;3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2278(B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6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.3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2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68835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9.3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10(C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4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688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68835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8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68835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8.4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ZM197M.PB7(C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3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6883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9.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HIV-16936-2.21(C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lt;3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8.8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C422661.8(B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.4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7.5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O4160.33(B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1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.0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68835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P45.2.00.G3 (C)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2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68835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4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68835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RW020.2(A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4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3.0</a:t>
                      </a:r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DEA9B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7</a:t>
                      </a:r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CC60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W965.26 (C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81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F162.LS(B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81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2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15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IV1157ipd (C)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4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28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15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1E2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1600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A-MLV	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lt;3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50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grpSp>
        <p:nvGrpSpPr>
          <p:cNvPr id="121" name="组合 120"/>
          <p:cNvGrpSpPr/>
          <p:nvPr/>
        </p:nvGrpSpPr>
        <p:grpSpPr>
          <a:xfrm>
            <a:off x="7132997" y="5362992"/>
            <a:ext cx="745718" cy="1119450"/>
            <a:chOff x="7919986" y="10520023"/>
            <a:chExt cx="745718" cy="1119450"/>
          </a:xfrm>
        </p:grpSpPr>
        <p:sp>
          <p:nvSpPr>
            <p:cNvPr id="122" name="矩形 121"/>
            <p:cNvSpPr/>
            <p:nvPr/>
          </p:nvSpPr>
          <p:spPr>
            <a:xfrm>
              <a:off x="7963528" y="10926691"/>
              <a:ext cx="157942" cy="163286"/>
            </a:xfrm>
            <a:prstGeom prst="rect">
              <a:avLst/>
            </a:prstGeom>
            <a:solidFill>
              <a:srgbClr val="FDEA9B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3" name="矩形 122"/>
            <p:cNvSpPr/>
            <p:nvPr/>
          </p:nvSpPr>
          <p:spPr>
            <a:xfrm>
              <a:off x="7963528" y="11097227"/>
              <a:ext cx="157942" cy="163286"/>
            </a:xfrm>
            <a:prstGeom prst="rect">
              <a:avLst/>
            </a:prstGeom>
            <a:solidFill>
              <a:srgbClr val="FCC601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4" name="矩形 123"/>
            <p:cNvSpPr/>
            <p:nvPr/>
          </p:nvSpPr>
          <p:spPr>
            <a:xfrm>
              <a:off x="7963528" y="11267763"/>
              <a:ext cx="157942" cy="163286"/>
            </a:xfrm>
            <a:prstGeom prst="rect">
              <a:avLst/>
            </a:prstGeom>
            <a:solidFill>
              <a:srgbClr val="F68835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5" name="矩形 124"/>
            <p:cNvSpPr/>
            <p:nvPr/>
          </p:nvSpPr>
          <p:spPr>
            <a:xfrm>
              <a:off x="7963528" y="11438299"/>
              <a:ext cx="157942" cy="163286"/>
            </a:xfrm>
            <a:prstGeom prst="rect">
              <a:avLst/>
            </a:prstGeom>
            <a:solidFill>
              <a:srgbClr val="ED1E23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6" name="文本框 125"/>
            <p:cNvSpPr txBox="1"/>
            <p:nvPr/>
          </p:nvSpPr>
          <p:spPr>
            <a:xfrm>
              <a:off x="7919986" y="10520023"/>
              <a:ext cx="7457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6012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IC</a:t>
              </a:r>
              <a:r>
                <a:rPr kumimoji="0" lang="en-US" altLang="zh-CN" sz="1000" b="0" i="0" u="none" strike="noStrike" kern="1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50</a:t>
              </a:r>
              <a:r>
                <a:rPr kumimoji="0" lang="zh-CN" altLang="en-US" sz="1000" b="0" i="0" u="none" strike="noStrike" kern="100" cap="none" spc="0" normalizeH="0" baseline="-25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l-GR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μ</a:t>
              </a: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/ml</a:t>
              </a:r>
              <a:endParaRPr kumimoji="0" lang="zh-CN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>
              <a:off x="8171163" y="11408641"/>
              <a:ext cx="4122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&lt;0.2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8" name="文本框 127"/>
            <p:cNvSpPr txBox="1"/>
            <p:nvPr/>
          </p:nvSpPr>
          <p:spPr>
            <a:xfrm>
              <a:off x="8153530" y="11225939"/>
              <a:ext cx="4475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0.2-2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9" name="文本框 128"/>
            <p:cNvSpPr txBox="1"/>
            <p:nvPr/>
          </p:nvSpPr>
          <p:spPr>
            <a:xfrm>
              <a:off x="8175003" y="11048326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2-1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0" name="文本框 129"/>
            <p:cNvSpPr txBox="1"/>
            <p:nvPr/>
          </p:nvSpPr>
          <p:spPr>
            <a:xfrm>
              <a:off x="8137500" y="10871938"/>
              <a:ext cx="4796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10-5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1" name="矩形 130"/>
            <p:cNvSpPr/>
            <p:nvPr/>
          </p:nvSpPr>
          <p:spPr>
            <a:xfrm>
              <a:off x="7963528" y="10756155"/>
              <a:ext cx="157942" cy="1632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2" name="文本框 131"/>
            <p:cNvSpPr txBox="1"/>
            <p:nvPr/>
          </p:nvSpPr>
          <p:spPr>
            <a:xfrm>
              <a:off x="8187193" y="10711601"/>
              <a:ext cx="38023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&gt;5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33" name="组合 132"/>
          <p:cNvGrpSpPr/>
          <p:nvPr/>
        </p:nvGrpSpPr>
        <p:grpSpPr>
          <a:xfrm>
            <a:off x="7105100" y="4196280"/>
            <a:ext cx="894797" cy="1118488"/>
            <a:chOff x="7906893" y="9236798"/>
            <a:chExt cx="894797" cy="1118488"/>
          </a:xfrm>
        </p:grpSpPr>
        <p:sp>
          <p:nvSpPr>
            <p:cNvPr id="134" name="矩形 133"/>
            <p:cNvSpPr/>
            <p:nvPr/>
          </p:nvSpPr>
          <p:spPr>
            <a:xfrm>
              <a:off x="7984899" y="9643466"/>
              <a:ext cx="157942" cy="163286"/>
            </a:xfrm>
            <a:prstGeom prst="rect">
              <a:avLst/>
            </a:prstGeom>
            <a:solidFill>
              <a:srgbClr val="FDEA9B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5" name="矩形 134"/>
            <p:cNvSpPr/>
            <p:nvPr/>
          </p:nvSpPr>
          <p:spPr>
            <a:xfrm>
              <a:off x="7984899" y="9814002"/>
              <a:ext cx="157942" cy="163286"/>
            </a:xfrm>
            <a:prstGeom prst="rect">
              <a:avLst/>
            </a:prstGeom>
            <a:solidFill>
              <a:srgbClr val="FCC601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6" name="矩形 135"/>
            <p:cNvSpPr/>
            <p:nvPr/>
          </p:nvSpPr>
          <p:spPr>
            <a:xfrm>
              <a:off x="7984899" y="9984538"/>
              <a:ext cx="157942" cy="163286"/>
            </a:xfrm>
            <a:prstGeom prst="rect">
              <a:avLst/>
            </a:prstGeom>
            <a:solidFill>
              <a:srgbClr val="F68835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7" name="矩形 136"/>
            <p:cNvSpPr/>
            <p:nvPr/>
          </p:nvSpPr>
          <p:spPr>
            <a:xfrm>
              <a:off x="7984899" y="10155074"/>
              <a:ext cx="157942" cy="163286"/>
            </a:xfrm>
            <a:prstGeom prst="rect">
              <a:avLst/>
            </a:prstGeom>
            <a:solidFill>
              <a:srgbClr val="ED1E23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8" name="文本框 137"/>
            <p:cNvSpPr txBox="1"/>
            <p:nvPr/>
          </p:nvSpPr>
          <p:spPr>
            <a:xfrm>
              <a:off x="7906893" y="9236798"/>
              <a:ext cx="8947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6012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lasma </a:t>
              </a:r>
              <a:r>
                <a:rPr kumimoji="0" lang="en-US" altLang="zh-CN" sz="1000" b="0" i="0" u="none" strike="noStrike" kern="1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ID</a:t>
              </a:r>
              <a:r>
                <a:rPr kumimoji="0" lang="en-US" altLang="zh-CN" sz="1000" b="0" i="0" u="none" strike="noStrike" kern="100" cap="none" spc="0" normalizeH="0" baseline="-25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50</a:t>
              </a:r>
              <a:r>
                <a:rPr kumimoji="0" lang="zh-CN" altLang="en-US" sz="1000" b="0" i="0" u="none" strike="noStrike" kern="100" cap="none" spc="0" normalizeH="0" baseline="-2500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endPara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139" name="文本框 138"/>
            <p:cNvSpPr txBox="1"/>
            <p:nvPr/>
          </p:nvSpPr>
          <p:spPr>
            <a:xfrm>
              <a:off x="8178653" y="10125416"/>
              <a:ext cx="440055" cy="2298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&gt;81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0" name="文本框 139"/>
            <p:cNvSpPr txBox="1"/>
            <p:nvPr/>
          </p:nvSpPr>
          <p:spPr>
            <a:xfrm>
              <a:off x="8094752" y="9942714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270-81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1" name="文本框 140"/>
            <p:cNvSpPr txBox="1"/>
            <p:nvPr/>
          </p:nvSpPr>
          <p:spPr>
            <a:xfrm>
              <a:off x="8132254" y="9765101"/>
              <a:ext cx="5437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91-27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2" name="文本框 141"/>
            <p:cNvSpPr txBox="1"/>
            <p:nvPr/>
          </p:nvSpPr>
          <p:spPr>
            <a:xfrm>
              <a:off x="8158871" y="9588713"/>
              <a:ext cx="4796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30-9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3" name="矩形 142"/>
            <p:cNvSpPr/>
            <p:nvPr/>
          </p:nvSpPr>
          <p:spPr>
            <a:xfrm>
              <a:off x="7984899" y="9472930"/>
              <a:ext cx="157942" cy="16328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4" name="文本框 143"/>
            <p:cNvSpPr txBox="1"/>
            <p:nvPr/>
          </p:nvSpPr>
          <p:spPr>
            <a:xfrm>
              <a:off x="8208564" y="9428376"/>
              <a:ext cx="38023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&lt;30</a:t>
              </a:r>
              <a:endParaRPr kumimoji="0" lang="zh-CN" alt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45" name="表格 144"/>
          <p:cNvGraphicFramePr>
            <a:graphicFrameLocks noGrp="1"/>
          </p:cNvGraphicFramePr>
          <p:nvPr/>
        </p:nvGraphicFramePr>
        <p:xfrm>
          <a:off x="1383081" y="6542114"/>
          <a:ext cx="5431531" cy="173083"/>
        </p:xfrm>
        <a:graphic>
          <a:graphicData uri="http://schemas.openxmlformats.org/drawingml/2006/table">
            <a:tbl>
              <a:tblPr/>
              <a:tblGrid>
                <a:gridCol w="184022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0774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278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2785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2785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ean  </a:t>
                      </a:r>
                      <a:r>
                        <a:rPr kumimoji="0" lang="en-US" altLang="zh-CN" sz="10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D</a:t>
                      </a:r>
                      <a:r>
                        <a:rPr kumimoji="0" lang="en-US" altLang="zh-CN" sz="1000" b="1" i="0" u="none" strike="noStrike" kern="100" cap="none" spc="0" normalizeH="0" baseline="-25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 </a:t>
                      </a:r>
                      <a:r>
                        <a:rPr kumimoji="0" lang="zh-CN" altLang="en-US" sz="1000" b="1" i="0" u="none" strike="noStrike" kern="100" cap="none" spc="0" normalizeH="0" baseline="-2500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 </a:t>
                      </a:r>
                      <a:r>
                        <a:rPr kumimoji="0" lang="en-US" altLang="zh-CN" sz="1100" b="1" i="0" u="none" strike="noStrike" kern="1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C</a:t>
                      </a:r>
                      <a:r>
                        <a:rPr kumimoji="0" lang="en-US" altLang="zh-CN" sz="1100" b="1" i="0" u="none" strike="noStrike" kern="100" cap="none" spc="0" normalizeH="0" baseline="-25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</a:t>
                      </a:r>
                      <a:r>
                        <a:rPr kumimoji="0" lang="zh-CN" altLang="en-US" sz="1100" b="1" i="0" u="none" strike="noStrike" kern="100" cap="none" spc="0" normalizeH="0" baseline="-2500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(</a:t>
                      </a:r>
                      <a:r>
                        <a:rPr lang="el-GR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/ml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5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.5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.5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9.39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46" name="表格 145"/>
          <p:cNvGraphicFramePr>
            <a:graphicFrameLocks noGrp="1"/>
          </p:cNvGraphicFramePr>
          <p:nvPr/>
        </p:nvGraphicFramePr>
        <p:xfrm>
          <a:off x="1404851" y="6356907"/>
          <a:ext cx="5431531" cy="173083"/>
        </p:xfrm>
        <a:graphic>
          <a:graphicData uri="http://schemas.openxmlformats.org/drawingml/2006/table">
            <a:tbl>
              <a:tblPr/>
              <a:tblGrid>
                <a:gridCol w="185729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9067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278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2785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2785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41148"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readth (%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6.2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algn="ctr" fontAlgn="ctr"/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0.5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1pPr>
                      <a:lvl2pPr marL="4800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2pPr>
                      <a:lvl3pPr marL="9601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3pPr>
                      <a:lvl4pPr marL="14401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4pPr>
                      <a:lvl5pPr marL="192024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5pPr>
                      <a:lvl6pPr marL="240030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6pPr>
                      <a:lvl7pPr marL="288036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7pPr>
                      <a:lvl8pPr marL="336042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8pPr>
                      <a:lvl9pPr marL="3840480" algn="l" defTabSz="960120" rtl="0" eaLnBrk="1" latinLnBrk="0" hangingPunct="1">
                        <a:defRPr sz="1890" kern="1200">
                          <a:solidFill>
                            <a:schemeClr val="tx1"/>
                          </a:solidFill>
                          <a:latin typeface="等线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1.4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6012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1.9%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03FABB7D-2D3A-F192-A51E-8D15BA44922F}"/>
              </a:ext>
            </a:extLst>
          </p:cNvPr>
          <p:cNvSpPr txBox="1"/>
          <p:nvPr/>
        </p:nvSpPr>
        <p:spPr>
          <a:xfrm>
            <a:off x="660400" y="7039191"/>
            <a:ext cx="8490857" cy="5770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5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ppendix  Figure 3. Recapitulation of the neutralization breadth in plasma by a combination of two different </a:t>
            </a:r>
            <a:r>
              <a:rPr kumimoji="0" lang="en-US" altLang="zh-CN" sz="1050" b="1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nAbs</a:t>
            </a:r>
            <a:r>
              <a:rPr kumimoji="0" lang="en-US" altLang="zh-CN" sz="105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kumimoji="0" lang="zh-CN" altLang="zh-CN" sz="105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05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neutralization potencies of JT18, J038, the J038 and JT18 mix as well as the G1015R plasma were determined against 21 viruses. The different colors represent the different neutralization potencies. </a:t>
            </a:r>
            <a:endParaRPr kumimoji="0" lang="zh-CN" altLang="zh-CN" sz="105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49580203-A30C-506C-E7F0-BD23FCDB38DE}"/>
              </a:ext>
            </a:extLst>
          </p:cNvPr>
          <p:cNvSpPr txBox="1"/>
          <p:nvPr/>
        </p:nvSpPr>
        <p:spPr>
          <a:xfrm>
            <a:off x="377102" y="223928"/>
            <a:ext cx="3662221" cy="5678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1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ppendix</a:t>
            </a:r>
            <a:endParaRPr kumimoji="0" lang="zh-CN" altLang="zh-CN" sz="1800" b="0" i="0" u="none" strike="noStrike" kern="1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zIxMjkzNTdjZWFhYjFmZTI0YzRhNGFiNzEyMzVhN2UifQ=="/>
</p:tagLst>
</file>

<file path=ppt/theme/theme1.xml><?xml version="1.0" encoding="utf-8"?>
<a:theme xmlns:a="http://schemas.openxmlformats.org/drawingml/2006/main" name="1_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588</TotalTime>
  <Words>805</Words>
  <Application>Microsoft Office PowerPoint</Application>
  <PresentationFormat>A3 Paper (297x420 mm)</PresentationFormat>
  <Paragraphs>311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1_Office 主题​​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XIN</dc:creator>
  <cp:lastModifiedBy>MDPI</cp:lastModifiedBy>
  <cp:revision>100</cp:revision>
  <dcterms:created xsi:type="dcterms:W3CDTF">2023-09-02T04:59:00Z</dcterms:created>
  <dcterms:modified xsi:type="dcterms:W3CDTF">2024-06-29T09:56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78A5E8D08014BD68F2EBBAEFCF4491F_13</vt:lpwstr>
  </property>
  <property fmtid="{D5CDD505-2E9C-101B-9397-08002B2CF9AE}" pid="3" name="KSOProductBuildVer">
    <vt:lpwstr>2052-12.1.0.15712</vt:lpwstr>
  </property>
</Properties>
</file>